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73985"/>
    <a:srgbClr val="7B0000"/>
    <a:srgbClr val="020202"/>
    <a:srgbClr val="B0B0B0"/>
    <a:srgbClr val="000000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D63ED8C-4FA4-488D-AF26-F4CC5251E0E5}" v="2" dt="2018-08-22T08:28:20.30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0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7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imo Mühlhaus" userId="1b6b3aba618dadac" providerId="LiveId" clId="{DCCCAD8A-BE7C-40E7-B835-1AF8D14CB392}"/>
  </pc:docChgLst>
  <pc:docChgLst>
    <pc:chgData name="Timo Mühlhaus" userId="1b6b3aba618dadac" providerId="LiveId" clId="{2D63ED8C-4FA4-488D-AF26-F4CC5251E0E5}"/>
    <pc:docChg chg="modSld">
      <pc:chgData name="Timo Mühlhaus" userId="1b6b3aba618dadac" providerId="LiveId" clId="{2D63ED8C-4FA4-488D-AF26-F4CC5251E0E5}" dt="2018-08-22T08:28:20.305" v="1" actId="20577"/>
      <pc:docMkLst>
        <pc:docMk/>
      </pc:docMkLst>
      <pc:sldChg chg="modSp">
        <pc:chgData name="Timo Mühlhaus" userId="1b6b3aba618dadac" providerId="LiveId" clId="{2D63ED8C-4FA4-488D-AF26-F4CC5251E0E5}" dt="2018-08-22T08:28:20.305" v="1" actId="20577"/>
        <pc:sldMkLst>
          <pc:docMk/>
          <pc:sldMk cId="871382570" sldId="259"/>
        </pc:sldMkLst>
        <pc:spChg chg="mod">
          <ac:chgData name="Timo Mühlhaus" userId="1b6b3aba618dadac" providerId="LiveId" clId="{2D63ED8C-4FA4-488D-AF26-F4CC5251E0E5}" dt="2018-08-22T08:28:20.305" v="1" actId="20577"/>
          <ac:spMkLst>
            <pc:docMk/>
            <pc:sldMk cId="871382570" sldId="259"/>
            <ac:spMk id="9" creationId="{8336B3DA-B28A-445F-8C9F-D95F089149EF}"/>
          </ac:spMkLst>
        </pc:spChg>
      </pc:sldChg>
    </pc:docChg>
  </pc:docChgLst>
  <pc:docChgLst>
    <pc:chgData name="Timo Mühlhaus" userId="1b6b3aba618dadac" providerId="LiveId" clId="{A8C9056F-0684-4820-A9DC-6E8908C4F24F}"/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681627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429548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661528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215925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952058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943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169864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7709047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304519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8138177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494361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BE3BC2-098B-4F41-B677-34B6E4578E18}" type="datetimeFigureOut">
              <a:rPr lang="LID4096" smtClean="0"/>
              <a:t>08/22/2018</a:t>
            </a:fld>
            <a:endParaRPr lang="LID4096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LID4096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CD0A60-5821-4655-9C88-CDD023597AF3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6772925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svg"/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12" Type="http://schemas.openxmlformats.org/officeDocument/2006/relationships/image" Target="../media/image11.png"/><Relationship Id="rId17" Type="http://schemas.openxmlformats.org/officeDocument/2006/relationships/image" Target="../media/image16.sv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svg"/><Relationship Id="rId5" Type="http://schemas.openxmlformats.org/officeDocument/2006/relationships/image" Target="../media/image4.svg"/><Relationship Id="rId15" Type="http://schemas.openxmlformats.org/officeDocument/2006/relationships/image" Target="../media/image14.sv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sv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sv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svg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phic 3">
            <a:extLst>
              <a:ext uri="{FF2B5EF4-FFF2-40B4-BE49-F238E27FC236}">
                <a16:creationId xmlns:a16="http://schemas.microsoft.com/office/drawing/2014/main" id="{62BE3635-9F3F-495A-BE7B-E659EE63B72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175317"/>
            <a:ext cx="3840480" cy="2924001"/>
          </a:xfrm>
          <a:prstGeom prst="rect">
            <a:avLst/>
          </a:prstGeom>
        </p:spPr>
      </p:pic>
      <p:pic>
        <p:nvPicPr>
          <p:cNvPr id="6" name="Graphic 5">
            <a:extLst>
              <a:ext uri="{FF2B5EF4-FFF2-40B4-BE49-F238E27FC236}">
                <a16:creationId xmlns:a16="http://schemas.microsoft.com/office/drawing/2014/main" id="{9EB44ACC-4E0A-4ED6-9439-F91E3E73F30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3186068" y="175316"/>
            <a:ext cx="3840480" cy="2924002"/>
          </a:xfrm>
          <a:prstGeom prst="rect">
            <a:avLst/>
          </a:prstGeom>
        </p:spPr>
      </p:pic>
      <p:pic>
        <p:nvPicPr>
          <p:cNvPr id="14" name="Graphic 13">
            <a:extLst>
              <a:ext uri="{FF2B5EF4-FFF2-40B4-BE49-F238E27FC236}">
                <a16:creationId xmlns:a16="http://schemas.microsoft.com/office/drawing/2014/main" id="{F188EEA5-1061-46D2-AE95-2614CA62B37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0" y="2341798"/>
            <a:ext cx="3840480" cy="2924546"/>
          </a:xfrm>
          <a:prstGeom prst="rect">
            <a:avLst/>
          </a:prstGeom>
        </p:spPr>
      </p:pic>
      <p:pic>
        <p:nvPicPr>
          <p:cNvPr id="16" name="Graphic 15">
            <a:extLst>
              <a:ext uri="{FF2B5EF4-FFF2-40B4-BE49-F238E27FC236}">
                <a16:creationId xmlns:a16="http://schemas.microsoft.com/office/drawing/2014/main" id="{F039B8E2-68A9-4807-9869-C674E343D12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3186068" y="2341798"/>
            <a:ext cx="3840480" cy="2924546"/>
          </a:xfrm>
          <a:prstGeom prst="rect">
            <a:avLst/>
          </a:prstGeom>
        </p:spPr>
      </p:pic>
      <p:pic>
        <p:nvPicPr>
          <p:cNvPr id="18" name="Graphic 17">
            <a:extLst>
              <a:ext uri="{FF2B5EF4-FFF2-40B4-BE49-F238E27FC236}">
                <a16:creationId xmlns:a16="http://schemas.microsoft.com/office/drawing/2014/main" id="{DE482163-9DAE-4FDC-ABAC-07A8A754CE85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0" y="4908919"/>
            <a:ext cx="3840480" cy="2924546"/>
          </a:xfrm>
          <a:prstGeom prst="rect">
            <a:avLst/>
          </a:prstGeom>
        </p:spPr>
      </p:pic>
      <p:pic>
        <p:nvPicPr>
          <p:cNvPr id="20" name="Graphic 19">
            <a:extLst>
              <a:ext uri="{FF2B5EF4-FFF2-40B4-BE49-F238E27FC236}">
                <a16:creationId xmlns:a16="http://schemas.microsoft.com/office/drawing/2014/main" id="{7391878E-5A67-4F79-8797-2DA97E31FD20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3186068" y="4908919"/>
            <a:ext cx="3840480" cy="2924546"/>
          </a:xfrm>
          <a:prstGeom prst="rect">
            <a:avLst/>
          </a:prstGeom>
        </p:spPr>
      </p:pic>
      <p:pic>
        <p:nvPicPr>
          <p:cNvPr id="22" name="Graphic 21">
            <a:extLst>
              <a:ext uri="{FF2B5EF4-FFF2-40B4-BE49-F238E27FC236}">
                <a16:creationId xmlns:a16="http://schemas.microsoft.com/office/drawing/2014/main" id="{F19CD402-16B0-4810-9982-C3E64F03F9BE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0" y="7375991"/>
            <a:ext cx="3840480" cy="2924546"/>
          </a:xfrm>
          <a:prstGeom prst="rect">
            <a:avLst/>
          </a:prstGeom>
        </p:spPr>
      </p:pic>
      <p:pic>
        <p:nvPicPr>
          <p:cNvPr id="24" name="Graphic 23">
            <a:extLst>
              <a:ext uri="{FF2B5EF4-FFF2-40B4-BE49-F238E27FC236}">
                <a16:creationId xmlns:a16="http://schemas.microsoft.com/office/drawing/2014/main" id="{5A6A25BC-BC78-4DDA-92EA-87EE0D218DC5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7"/>
              </a:ext>
            </a:extLst>
          </a:blip>
          <a:stretch>
            <a:fillRect/>
          </a:stretch>
        </p:blipFill>
        <p:spPr>
          <a:xfrm>
            <a:off x="3186068" y="7376263"/>
            <a:ext cx="3840480" cy="29240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62795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c 2">
            <a:extLst>
              <a:ext uri="{FF2B5EF4-FFF2-40B4-BE49-F238E27FC236}">
                <a16:creationId xmlns:a16="http://schemas.microsoft.com/office/drawing/2014/main" id="{EB9BEBFA-2163-4268-BFC9-B3C523E093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68382"/>
            <a:ext cx="3840480" cy="2924546"/>
          </a:xfrm>
          <a:prstGeom prst="rect">
            <a:avLst/>
          </a:prstGeom>
        </p:spPr>
      </p:pic>
      <p:pic>
        <p:nvPicPr>
          <p:cNvPr id="7" name="Graphic 6">
            <a:extLst>
              <a:ext uri="{FF2B5EF4-FFF2-40B4-BE49-F238E27FC236}">
                <a16:creationId xmlns:a16="http://schemas.microsoft.com/office/drawing/2014/main" id="{20A4DC92-C8C4-4C89-8643-A7836146237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3129094" y="68382"/>
            <a:ext cx="3840480" cy="292454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336B3DA-B28A-445F-8C9F-D95F089149EF}"/>
              </a:ext>
            </a:extLst>
          </p:cNvPr>
          <p:cNvSpPr txBox="1"/>
          <p:nvPr/>
        </p:nvSpPr>
        <p:spPr>
          <a:xfrm>
            <a:off x="473987" y="2287906"/>
            <a:ext cx="5021779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900" b="1">
                <a:latin typeface="Arial" panose="020B0604020202020204" pitchFamily="34" charset="0"/>
                <a:cs typeface="Arial" panose="020B0604020202020204" pitchFamily="34" charset="0"/>
              </a:rPr>
              <a:t>Figure 2.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Experimental evaluation of the selection process.</a:t>
            </a:r>
          </a:p>
          <a:p>
            <a:pPr algn="just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mparison of d::pPop prediction results of the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QConCAT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protein queries with PTPs selected and experimentally validated surrogate peptides (orange dots).</a:t>
            </a:r>
          </a:p>
        </p:txBody>
      </p:sp>
    </p:spTree>
    <p:extLst>
      <p:ext uri="{BB962C8B-B14F-4D97-AF65-F5344CB8AC3E}">
        <p14:creationId xmlns:p14="http://schemas.microsoft.com/office/powerpoint/2010/main" val="8713825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27</TotalTime>
  <Words>35</Words>
  <Application>Microsoft Office PowerPoint</Application>
  <PresentationFormat>A4 Paper (210x297 mm)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Schroda</dc:creator>
  <cp:lastModifiedBy>Timo Mühlhaus</cp:lastModifiedBy>
  <cp:revision>28</cp:revision>
  <dcterms:created xsi:type="dcterms:W3CDTF">2018-04-27T10:11:01Z</dcterms:created>
  <dcterms:modified xsi:type="dcterms:W3CDTF">2018-08-22T08:28:23Z</dcterms:modified>
</cp:coreProperties>
</file>